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62" r:id="rId2"/>
    <p:sldId id="269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12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094"/>
    <p:restoredTop sz="96327"/>
  </p:normalViewPr>
  <p:slideViewPr>
    <p:cSldViewPr snapToObjects="1">
      <p:cViewPr varScale="1">
        <p:scale>
          <a:sx n="89" d="100"/>
          <a:sy n="89" d="100"/>
        </p:scale>
        <p:origin x="3176" y="168"/>
      </p:cViewPr>
      <p:guideLst>
        <p:guide orient="horz" pos="3312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Objects="1">
      <p:cViewPr varScale="1">
        <p:scale>
          <a:sx n="120" d="100"/>
          <a:sy n="120" d="100"/>
        </p:scale>
        <p:origin x="5032" y="1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086972-B8E0-C24A-B90B-3C85F1B2D5D9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E8D49B-7C5F-D443-8A22-2923A6B2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000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E8D49B-7C5F-D443-8A22-2923A6B2765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1487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1" indent="0" algn="ctr">
              <a:buNone/>
              <a:defRPr sz="1500"/>
            </a:lvl2pPr>
            <a:lvl3pPr marL="685743" indent="0" algn="ctr">
              <a:buNone/>
              <a:defRPr sz="1350"/>
            </a:lvl3pPr>
            <a:lvl4pPr marL="1028614" indent="0" algn="ctr">
              <a:buNone/>
              <a:defRPr sz="1200"/>
            </a:lvl4pPr>
            <a:lvl5pPr marL="1371484" indent="0" algn="ctr">
              <a:buNone/>
              <a:defRPr sz="1200"/>
            </a:lvl5pPr>
            <a:lvl6pPr marL="1714356" indent="0" algn="ctr">
              <a:buNone/>
              <a:defRPr sz="1200"/>
            </a:lvl6pPr>
            <a:lvl7pPr marL="2057228" indent="0" algn="ctr">
              <a:buNone/>
              <a:defRPr sz="1200"/>
            </a:lvl7pPr>
            <a:lvl8pPr marL="2400098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48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183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048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594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9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9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4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9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766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475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4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1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4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6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1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4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6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901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813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224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1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4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897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71" indent="0">
              <a:buNone/>
              <a:defRPr sz="2100"/>
            </a:lvl2pPr>
            <a:lvl3pPr marL="685743" indent="0">
              <a:buNone/>
              <a:defRPr sz="1800"/>
            </a:lvl3pPr>
            <a:lvl4pPr marL="1028614" indent="0">
              <a:buNone/>
              <a:defRPr sz="1500"/>
            </a:lvl4pPr>
            <a:lvl5pPr marL="1371484" indent="0">
              <a:buNone/>
              <a:defRPr sz="1500"/>
            </a:lvl5pPr>
            <a:lvl6pPr marL="1714356" indent="0">
              <a:buNone/>
              <a:defRPr sz="1500"/>
            </a:lvl6pPr>
            <a:lvl7pPr marL="2057228" indent="0">
              <a:buNone/>
              <a:defRPr sz="1500"/>
            </a:lvl7pPr>
            <a:lvl8pPr marL="2400098" indent="0">
              <a:buNone/>
              <a:defRPr sz="1500"/>
            </a:lvl8pPr>
            <a:lvl9pPr marL="274297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1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4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060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1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1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6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004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4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2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4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1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43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4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6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tiff"/><Relationship Id="rId4" Type="http://schemas.openxmlformats.org/officeDocument/2006/relationships/image" Target="../media/image2.png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picture containing text, orange&#10;&#10;Description automatically generated">
            <a:extLst>
              <a:ext uri="{FF2B5EF4-FFF2-40B4-BE49-F238E27FC236}">
                <a16:creationId xmlns:a16="http://schemas.microsoft.com/office/drawing/2014/main" id="{9B8FF0DA-260C-3EF2-D91D-3C2B44F4D9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4154" y="3738928"/>
            <a:ext cx="5701054" cy="270911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D678992-B232-C04F-83C4-30CFC6E2D1C7}"/>
              </a:ext>
            </a:extLst>
          </p:cNvPr>
          <p:cNvSpPr txBox="1"/>
          <p:nvPr/>
        </p:nvSpPr>
        <p:spPr>
          <a:xfrm>
            <a:off x="61017" y="579777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0C51F3C-47E1-0246-ADF4-65E6D46C40D3}"/>
              </a:ext>
            </a:extLst>
          </p:cNvPr>
          <p:cNvSpPr txBox="1"/>
          <p:nvPr/>
        </p:nvSpPr>
        <p:spPr>
          <a:xfrm>
            <a:off x="61017" y="3490907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6D698EF-6FAE-7442-BACA-BC4009CA94D8}"/>
              </a:ext>
            </a:extLst>
          </p:cNvPr>
          <p:cNvSpPr txBox="1"/>
          <p:nvPr/>
        </p:nvSpPr>
        <p:spPr>
          <a:xfrm>
            <a:off x="61017" y="6413392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B0FE3B-54CA-7C49-B2A9-7A4BB3322DEF}"/>
              </a:ext>
            </a:extLst>
          </p:cNvPr>
          <p:cNvSpPr txBox="1"/>
          <p:nvPr/>
        </p:nvSpPr>
        <p:spPr>
          <a:xfrm>
            <a:off x="3241048" y="6413392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8FCD8E03-C506-4E42-A537-EEE1853B65C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4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41125" y="8872187"/>
            <a:ext cx="1555019" cy="32985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C4AFB9B-C11D-E64A-8FCF-07F0C76B550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1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38012" y="7820123"/>
            <a:ext cx="1548632" cy="32849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2C29686-AC2D-2243-A6A0-A42B138F0F2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1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38012" y="7385137"/>
            <a:ext cx="1541498" cy="32698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F5ED5ED-3195-2C4C-B185-F080EA0254D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39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41474" y="8427159"/>
            <a:ext cx="1548411" cy="32845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94CAC3C-0845-1B4F-94BA-181FA30AFD62}"/>
              </a:ext>
            </a:extLst>
          </p:cNvPr>
          <p:cNvSpPr txBox="1"/>
          <p:nvPr/>
        </p:nvSpPr>
        <p:spPr>
          <a:xfrm>
            <a:off x="315976" y="7421186"/>
            <a:ext cx="12019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Stat1 -</a:t>
            </a:r>
            <a:r>
              <a:rPr lang="el-GR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(91kDa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9FCFFBE-E7B7-1348-B528-E397EB087733}"/>
              </a:ext>
            </a:extLst>
          </p:cNvPr>
          <p:cNvSpPr txBox="1"/>
          <p:nvPr/>
        </p:nvSpPr>
        <p:spPr>
          <a:xfrm>
            <a:off x="321059" y="7548629"/>
            <a:ext cx="12019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Stat1 -</a:t>
            </a:r>
            <a:r>
              <a:rPr lang="el-GR" sz="7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(84kDa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E56D39E-F630-6542-92DE-0D87EE67BCDA}"/>
              </a:ext>
            </a:extLst>
          </p:cNvPr>
          <p:cNvSpPr txBox="1"/>
          <p:nvPr/>
        </p:nvSpPr>
        <p:spPr>
          <a:xfrm>
            <a:off x="321059" y="7904229"/>
            <a:ext cx="12019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Gapdh (37kDa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E804AD3-0F44-B745-BDB6-A2FE2A29D4B4}"/>
              </a:ext>
            </a:extLst>
          </p:cNvPr>
          <p:cNvSpPr txBox="1"/>
          <p:nvPr/>
        </p:nvSpPr>
        <p:spPr>
          <a:xfrm>
            <a:off x="230104" y="8443396"/>
            <a:ext cx="155103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p-Stat1 -</a:t>
            </a:r>
            <a:r>
              <a:rPr lang="el-GR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(91kDa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16153F2-DBB7-DE49-A88D-15A399B223AF}"/>
              </a:ext>
            </a:extLst>
          </p:cNvPr>
          <p:cNvSpPr txBox="1"/>
          <p:nvPr/>
        </p:nvSpPr>
        <p:spPr>
          <a:xfrm>
            <a:off x="230104" y="8552286"/>
            <a:ext cx="153587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p-Stat1 -</a:t>
            </a:r>
            <a:r>
              <a:rPr lang="el-GR" sz="7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(84kDa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064E619-6C14-0F4B-8821-72D60369D43C}"/>
              </a:ext>
            </a:extLst>
          </p:cNvPr>
          <p:cNvSpPr txBox="1"/>
          <p:nvPr/>
        </p:nvSpPr>
        <p:spPr>
          <a:xfrm>
            <a:off x="350205" y="8962337"/>
            <a:ext cx="12019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Gapdh (37kDa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7C00A98-A07F-4A4C-B110-F2B2870BBFED}"/>
              </a:ext>
            </a:extLst>
          </p:cNvPr>
          <p:cNvSpPr txBox="1"/>
          <p:nvPr/>
        </p:nvSpPr>
        <p:spPr>
          <a:xfrm rot="18924555">
            <a:off x="1068697" y="6940413"/>
            <a:ext cx="10041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497AB8C-21CD-134E-80C4-70DE3E276E80}"/>
              </a:ext>
            </a:extLst>
          </p:cNvPr>
          <p:cNvSpPr txBox="1"/>
          <p:nvPr/>
        </p:nvSpPr>
        <p:spPr>
          <a:xfrm rot="18924555">
            <a:off x="1846777" y="6948010"/>
            <a:ext cx="10041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trl + IFN 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9BFADBA-EE21-E646-99DD-38CD5699E961}"/>
              </a:ext>
            </a:extLst>
          </p:cNvPr>
          <p:cNvSpPr txBox="1"/>
          <p:nvPr/>
        </p:nvSpPr>
        <p:spPr>
          <a:xfrm rot="18924555">
            <a:off x="1297297" y="6946428"/>
            <a:ext cx="10041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gPtpn2 -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AA31B05-7DF2-3F4B-9B0B-1CA642F753BB}"/>
              </a:ext>
            </a:extLst>
          </p:cNvPr>
          <p:cNvSpPr txBox="1"/>
          <p:nvPr/>
        </p:nvSpPr>
        <p:spPr>
          <a:xfrm rot="18924555">
            <a:off x="2040643" y="6892774"/>
            <a:ext cx="11274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gPtpn2 -2 + IFN 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5039F8D-ABB5-2A41-ACEF-D77DCC4D60BD}"/>
              </a:ext>
            </a:extLst>
          </p:cNvPr>
          <p:cNvSpPr txBox="1"/>
          <p:nvPr/>
        </p:nvSpPr>
        <p:spPr>
          <a:xfrm rot="18924555">
            <a:off x="1593960" y="6939405"/>
            <a:ext cx="10041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gPtpn2 -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3232714-A31C-2C40-829D-069B601A7405}"/>
              </a:ext>
            </a:extLst>
          </p:cNvPr>
          <p:cNvSpPr txBox="1"/>
          <p:nvPr/>
        </p:nvSpPr>
        <p:spPr>
          <a:xfrm rot="18924555">
            <a:off x="2317418" y="6894452"/>
            <a:ext cx="11274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gPtpn2 -3 + IFN 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63AD277-A219-874F-9CCF-7FF7057D07B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2437" y="718276"/>
            <a:ext cx="5700530" cy="2853961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B0958A12-61C3-084B-B3DC-0288D6E6444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11421" y="7175500"/>
            <a:ext cx="1676400" cy="212090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E540FC71-5627-1E42-BB91-0C209811EEC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987821" y="7162800"/>
            <a:ext cx="1676400" cy="21336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2E1B6F3-CD34-9D93-6EE5-CC12D098B26E}"/>
              </a:ext>
            </a:extLst>
          </p:cNvPr>
          <p:cNvSpPr txBox="1"/>
          <p:nvPr/>
        </p:nvSpPr>
        <p:spPr>
          <a:xfrm>
            <a:off x="1930651" y="161926"/>
            <a:ext cx="2844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</p:txBody>
      </p:sp>
    </p:spTree>
    <p:extLst>
      <p:ext uri="{BB962C8B-B14F-4D97-AF65-F5344CB8AC3E}">
        <p14:creationId xmlns:p14="http://schemas.microsoft.com/office/powerpoint/2010/main" val="10369450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8BE5121-FC5A-6350-3779-0CE0B0137E0E}"/>
              </a:ext>
            </a:extLst>
          </p:cNvPr>
          <p:cNvSpPr txBox="1"/>
          <p:nvPr/>
        </p:nvSpPr>
        <p:spPr>
          <a:xfrm>
            <a:off x="914400" y="882462"/>
            <a:ext cx="5295900" cy="40705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pplementary Figure S3. 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T-qPCR analysis of the indicated mRNAs in control or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tpn2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KO CT26 treated for 24 h with 100 ng/mL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r PBS. P-values compare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tpn2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KO to the control unde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reatment. Data are the mean ± SEM of n = 3.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T-qPCR analysis of the indicated mRNAs in control or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tpn2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KO MC38 treated for 24 h with 100 ng/mL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r PBS. P-values compare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tpn2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KO to the control unde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reatment. Data are the mean ± SEM of n = 3.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C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Western blot analysis of Stat1 or phosphorylated Stat1 in CT26 cells treated as described.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D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TS cell proliferation assay of control or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tpn2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KO CT26 (left) and MC38 (right) cells treated with the indicated combinations of PBS,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100 ng/mL, and TNFα 10 ng/ml for 72 h. Data are the mean ± SEM of n = 6 for CT26 and n = 3 for MC38. 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8292183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63</TotalTime>
  <Words>250</Words>
  <Application>Microsoft Macintosh PowerPoint</Application>
  <PresentationFormat>A4 Paper (210x297 mm)</PresentationFormat>
  <Paragraphs>23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u zhouting</dc:creator>
  <cp:lastModifiedBy>Rana, Tariq</cp:lastModifiedBy>
  <cp:revision>385</cp:revision>
  <cp:lastPrinted>2022-06-09T01:30:53Z</cp:lastPrinted>
  <dcterms:created xsi:type="dcterms:W3CDTF">2022-03-29T23:12:58Z</dcterms:created>
  <dcterms:modified xsi:type="dcterms:W3CDTF">2022-12-14T19:42:36Z</dcterms:modified>
</cp:coreProperties>
</file>